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5" r:id="rId3"/>
    <p:sldId id="272" r:id="rId4"/>
    <p:sldId id="279" r:id="rId5"/>
    <p:sldId id="28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DBF0"/>
    <a:srgbClr val="C7EED9"/>
    <a:srgbClr val="0EDAF0"/>
    <a:srgbClr val="F60EB4"/>
    <a:srgbClr val="C3DA3A"/>
    <a:srgbClr val="E487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5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F971E6-C8B8-4940-8FDF-4937014469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DABDF4-2C4F-4394-BBA6-423FE21BF8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639E8-E56E-41FE-B8DA-AC3245D77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57FFD-1D03-4105-BB8F-4FD3ECFB2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74F970-D208-493E-99B4-C11CE7FE3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610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A0A295-F5DE-43F6-9EB7-08CE728C14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C8FE17-66AF-4994-A110-D71A3ADF57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5C2974-BA6F-4F97-B4B2-A13605E77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FD0A8-8D6E-475B-BC63-861C007C7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6E283-1148-444C-A401-9A235C833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424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341505-D32A-4C86-8AF7-E05E439006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7EAEFB-7C5A-4B21-B50A-ED1E5A35FD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878D3-0178-4DC3-B634-745635715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7CD4B5-64DF-4D45-A240-551AD8668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41E4E-CD4C-49C7-A4E2-DE0810E45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547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1BD81F-2031-4250-9662-7E1F311A3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B74C36-43AD-4171-A60E-7B327E44FD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4BB78A-0586-4C03-A36E-8A47EAE21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666CAE-9735-4D0E-BCB6-CE34D6253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50C16E-BA0B-47E8-B4C2-27CF088B6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007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AAD70F-FFBC-44C2-B182-E8AB2E13D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FC283C-F62A-43E5-B93A-9BD70B461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003D43-32C5-486B-9DF7-BDFC6AB93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E702B-8AC0-4D69-BADA-E78513437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F353D8-6C25-4CEA-9A21-8B1B37CBB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854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1B5BF-2C65-4A8C-9C13-E7A44D4324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D5B58F-4C88-44FA-A739-48BE19E4B6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7DCF52-783E-426E-8088-CDFD1099D3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588B2-71EF-4727-B2A9-CB19CE62D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00EB5D-5449-45C7-96B4-3338C249C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FC51BC-E867-4677-9888-6DEF818DD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983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2F6ABA-3A7D-4711-ABE1-9D3B449EA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B272AA-4013-4A6A-9246-21DF5C8F15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6A3589-D023-4832-8D1D-472D7CFC2D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4E47EA-6DC8-4F68-B799-C36C1AEFEE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9618CA-8EC6-4CE7-BC0B-28D6DE182C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AFEE48-797A-4E5D-9C41-819400797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2C3EA3-E57D-4C5E-A2C6-8D010DEE4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6ABD98-BCAA-4534-BC26-4222F57DA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385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4CD1A-C27D-45EE-8550-26C48B7AC1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855694-75B1-4FF0-8438-7E09BD916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A1C15E-D538-48C1-A74B-5E25AA2EF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9884EB-0837-4B1B-A7A7-C76B2C4E8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065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E328C2-F39F-4A34-A8F7-0F86AB40F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F85D32-25CD-4986-B8F5-FD8AE1B06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905034-49C1-4E4C-AA34-981EBE2E3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972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C0BCFD-D3F2-40CE-8647-58558F2F6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F1CEF7-9376-4960-8225-77515805E6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78ACD6-E43A-4C2E-8D28-EBF03FA9D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06DF85-0E97-435F-BE4B-A58781716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F0535D-2922-4DB4-9308-DEDF72758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C4038E-37C7-435E-823D-F8F935B77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567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D2743-EEC5-46EC-B95B-A69CF5559E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F5801B-89B8-4BEF-B626-CE03259E4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D119EA-D7A5-4B91-9FCD-B3BF494A5B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74F861-107E-4635-AFFE-B71ED485C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55717A-8E22-42AB-BD65-21252945D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5E494B-3CAD-411A-B234-BCC8F6472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664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8B134A-3A95-4875-8148-B4ED42B581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2E1F80-E744-440D-9A4E-773779A21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08E2B7-9BF2-47B8-AEB6-99F80C4C0F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86EDF-0AEF-4597-879E-F0F9D0C7A7D2}" type="datetimeFigureOut">
              <a:rPr lang="en-US" smtClean="0"/>
              <a:t>1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C0C506-5B33-460E-AFB1-48A955D209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CAEF26-2781-4527-A6F2-532287E59D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F4E989-8730-45A8-9D74-281051013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733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 descr="A screenshot of a cell phone&#10;&#10;Description automatically generated">
            <a:extLst>
              <a:ext uri="{FF2B5EF4-FFF2-40B4-BE49-F238E27FC236}">
                <a16:creationId xmlns:a16="http://schemas.microsoft.com/office/drawing/2014/main" id="{774866C4-94AD-EE4C-B29B-A192FCF4FD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saturation sat="2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52160" y="204602"/>
            <a:ext cx="9252930" cy="4861141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96D509B4-5582-3B4D-B298-7214F237071C}"/>
              </a:ext>
            </a:extLst>
          </p:cNvPr>
          <p:cNvSpPr/>
          <p:nvPr/>
        </p:nvSpPr>
        <p:spPr>
          <a:xfrm>
            <a:off x="558187" y="5578975"/>
            <a:ext cx="11240877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I2M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ecallin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Scor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graph of analyzed reads (green bars) by sequences length (bases) with an average of 7,546 base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of reads count per hour that workflow was successful (light blue bars) and percentage of reads count per hour that failed the quality score filter (Blue bars).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graph of quality score by read count, failed reads are &lt; 7 score value (gray bars) and successful reads are &gt; 7 score value (green bars) with a mode of 7.85 score value. </a:t>
            </a:r>
          </a:p>
        </p:txBody>
      </p:sp>
    </p:spTree>
    <p:extLst>
      <p:ext uri="{BB962C8B-B14F-4D97-AF65-F5344CB8AC3E}">
        <p14:creationId xmlns:p14="http://schemas.microsoft.com/office/powerpoint/2010/main" val="1071214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C94CD5FD-DEB4-43B7-935D-A9426D4CB2C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saturation sat="3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07933" y="0"/>
            <a:ext cx="9776134" cy="569093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3B4F7E5-B00D-456F-AB10-DA7B81BD62DA}"/>
              </a:ext>
            </a:extLst>
          </p:cNvPr>
          <p:cNvSpPr txBox="1"/>
          <p:nvPr/>
        </p:nvSpPr>
        <p:spPr>
          <a:xfrm>
            <a:off x="271802" y="5813288"/>
            <a:ext cx="1164839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stribution of subsystems founds in the polyvalent bacteriophage FP01 genom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pid Annotation System Technology (RAST) annotation data provided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ystems categories pie chart represented by purple color (Nucleoside and nucleotides) and grey color (Phages, Prophages, Transposable elements, Plasmid). </a:t>
            </a:r>
            <a:b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age Search Tool (PHAST) annotation CDS type distribution along the complete genome of phage FP01. Specific phage CDSs types are described by numbers (1-15) and colors for each type. Graphic present only annotated proteins for: tail shaft (sha); Tail fiber (fib); other phage-like protein (PLP) and Coa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     </a:t>
            </a:r>
          </a:p>
        </p:txBody>
      </p:sp>
    </p:spTree>
    <p:extLst>
      <p:ext uri="{BB962C8B-B14F-4D97-AF65-F5344CB8AC3E}">
        <p14:creationId xmlns:p14="http://schemas.microsoft.com/office/powerpoint/2010/main" val="20242412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C454AC47-360E-4D65-B388-F3FAF0BDA5CE}"/>
              </a:ext>
            </a:extLst>
          </p:cNvPr>
          <p:cNvSpPr txBox="1"/>
          <p:nvPr/>
        </p:nvSpPr>
        <p:spPr>
          <a:xfrm>
            <a:off x="0" y="4958205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ative phage FP01 whole genome analysis. Average nucleotide identity (ANI) table of whole genome alignment. Forty-on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dovirict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teriophages complete genome were used, and Enterobacteria phage M13 (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ulavir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set up as outgroup. Analysis was computed by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CBi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53BEB0F6-01DF-F71E-0CF3-6DD12F849D2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0" y="699223"/>
            <a:ext cx="12192000" cy="4099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11391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4401236E-EE3B-440C-AACE-044A9175631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7361"/>
          <a:stretch/>
        </p:blipFill>
        <p:spPr>
          <a:xfrm>
            <a:off x="444509" y="53075"/>
            <a:ext cx="5320566" cy="68049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3E1E494-B431-4995-9D06-9F79777376DD}"/>
              </a:ext>
            </a:extLst>
          </p:cNvPr>
          <p:cNvSpPr txBox="1"/>
          <p:nvPr/>
        </p:nvSpPr>
        <p:spPr>
          <a:xfrm>
            <a:off x="5939246" y="3429000"/>
            <a:ext cx="6096000" cy="6755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ail multiple alignment. </a:t>
            </a:r>
            <a:r>
              <a:rPr lang="en-CA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 protein Pb5 from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cherichia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age T5 (GenBank: AAX12083.1) and hypothetical protein HWB87_gp108 from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cherichia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age FP01 (NCBI Reference Sequence: YP_009841487.1)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8082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52763758-EED8-4AEE-8E14-7B9ECBE96D5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7422" y="0"/>
            <a:ext cx="7308937" cy="68580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2C0F86-DBE1-4C62-9291-A4063BE93506}"/>
              </a:ext>
            </a:extLst>
          </p:cNvPr>
          <p:cNvSpPr txBox="1"/>
          <p:nvPr/>
        </p:nvSpPr>
        <p:spPr>
          <a:xfrm>
            <a:off x="4023360" y="6121534"/>
            <a:ext cx="7700624" cy="6755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</a:t>
            </a:r>
            <a:r>
              <a:rPr lang="en-CA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-protein complex analysis.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idues on the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huA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inding interface.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idues on the hypothetical protein HWB87_gp108 binding interface.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Binding residues pairs.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.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edicted binding affinity and dissociation constant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042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06</TotalTime>
  <Words>360</Words>
  <Application>Microsoft Macintosh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 ignacio vasquez</dc:creator>
  <cp:lastModifiedBy>Santander, Javier</cp:lastModifiedBy>
  <cp:revision>44</cp:revision>
  <dcterms:created xsi:type="dcterms:W3CDTF">2021-05-30T17:10:02Z</dcterms:created>
  <dcterms:modified xsi:type="dcterms:W3CDTF">2023-01-16T02:20:08Z</dcterms:modified>
</cp:coreProperties>
</file>